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6E59C4-B8E9-42E4-9DDB-FA698CA84C2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8FF588-1604-4BC2-9253-8043864B9B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55F14A-896E-4DFF-BDD9-E350CC9B75F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98A545-02B4-4D73-800A-5E8A1AD04A3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940AA9-329D-4485-82CD-C02F016B83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6E9795-29BC-45D6-ABCD-477A9DFD5B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06B032-6CF7-4BA4-83A0-213D7472A5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2E0744-25E9-4680-B540-E4BF13B54C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D52D1D-B2C4-45A3-872D-270FD6EBBB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5210BE-0F3C-42A5-AC79-ABE0E75F44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0A1820-4458-4E22-81EF-F1DF62B9F6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10878F-1C18-44B8-AD6F-8CBD3FD725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31996FA-640F-4EF6-BAFD-3198FD16DC51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7101000" y="1193760"/>
          <a:ext cx="3394080" cy="2546280"/>
        </p:xfrm>
        <a:graphic>
          <a:graphicData uri="http://schemas.openxmlformats.org/drawingml/2006/table">
            <a:tbl>
              <a:tblPr/>
              <a:tblGrid>
                <a:gridCol w="493560"/>
                <a:gridCol w="538200"/>
                <a:gridCol w="816120"/>
                <a:gridCol w="785520"/>
                <a:gridCol w="760680"/>
              </a:tblGrid>
              <a:tr h="27936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ne I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ne nam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-inflorescence-inflorescenc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florescence-flowerin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florescence-inflorescenc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292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260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BI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a3c53"/>
                    </a:solidFill>
                  </a:tcPr>
                </a:tc>
              </a:tr>
              <a:tr h="14148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70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BI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93a4f"/>
                    </a:solidFill>
                  </a:tcPr>
                </a:tc>
              </a:tr>
              <a:tr h="14112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172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PK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c4058"/>
                    </a:solidFill>
                  </a:tcPr>
                </a:tc>
              </a:tr>
              <a:tr h="14112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31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NGC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8394e"/>
                    </a:solidFill>
                  </a:tcPr>
                </a:tc>
              </a:tr>
              <a:tr h="14292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464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NGC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8394e"/>
                    </a:solidFill>
                  </a:tcPr>
                </a:tc>
              </a:tr>
              <a:tr h="14148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239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NGC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a3c52"/>
                    </a:solidFill>
                  </a:tcPr>
                </a:tc>
              </a:tr>
              <a:tr h="14112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464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NGC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7364a"/>
                    </a:solidFill>
                  </a:tcPr>
                </a:tc>
              </a:tr>
              <a:tr h="14148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010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NGC1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a5679"/>
                    </a:solidFill>
                  </a:tcPr>
                </a:tc>
              </a:tr>
              <a:tr h="14112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216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RP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1d1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4292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673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c4058"/>
                    </a:solidFill>
                  </a:tcPr>
                </a:tc>
              </a:tr>
              <a:tr h="14148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479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BOH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93a50"/>
                    </a:solidFill>
                  </a:tcPr>
                </a:tc>
              </a:tr>
              <a:tr h="14112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692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PK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d415a"/>
                    </a:solidFill>
                  </a:tcPr>
                </a:tc>
              </a:tr>
              <a:tr h="14148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085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NRK2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43244"/>
                    </a:solidFill>
                  </a:tcPr>
                </a:tc>
              </a:tr>
              <a:tr h="14256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82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NRK2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d415a"/>
                    </a:solidFill>
                  </a:tcPr>
                </a:tc>
              </a:tr>
              <a:tr h="14148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260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G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.2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81818"/>
                    </a:solidFill>
                  </a:tcPr>
                </a:tc>
              </a:tr>
              <a:tr h="14112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259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G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2.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4.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.8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42" name=""/>
          <p:cNvGraphicFramePr/>
          <p:nvPr/>
        </p:nvGraphicFramePr>
        <p:xfrm>
          <a:off x="2600280" y="1190520"/>
          <a:ext cx="3257640" cy="4135680"/>
        </p:xfrm>
        <a:graphic>
          <a:graphicData uri="http://schemas.openxmlformats.org/drawingml/2006/table">
            <a:tbl>
              <a:tblPr/>
              <a:tblGrid>
                <a:gridCol w="530280"/>
                <a:gridCol w="511200"/>
                <a:gridCol w="798480"/>
                <a:gridCol w="733320"/>
                <a:gridCol w="684360"/>
              </a:tblGrid>
              <a:tr h="2872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ne I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ne nam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-inflorescence-inflorescenc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florescence-flowerin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florescence-inflorescenc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44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103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RD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c597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f0b0b"/>
                    </a:solidFill>
                  </a:tcPr>
                </a:tc>
              </a:tr>
              <a:tr h="1126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308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STF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30b0b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26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031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STF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a5578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34b68"/>
                    </a:solidFill>
                  </a:tcPr>
                </a:tc>
              </a:tr>
              <a:tr h="1144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172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STF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a0505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26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294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STU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70909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.2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  <a:tr h="1126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294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STU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d5a7f"/>
                    </a:solidFill>
                  </a:tcPr>
                </a:tc>
              </a:tr>
              <a:tr h="1126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271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STU1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85273"/>
                    </a:solidFill>
                  </a:tcPr>
                </a:tc>
              </a:tr>
              <a:tr h="11412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596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STU1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b0a0a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.3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  <a:tr h="1126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597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STU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46690"/>
                    </a:solidFill>
                  </a:tcPr>
                </a:tc>
              </a:tr>
              <a:tr h="11304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83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STU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d75a7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412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171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STU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.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  <a:tr h="1126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529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XII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00b0b"/>
                    </a:solidFill>
                  </a:tcPr>
                </a:tc>
              </a:tr>
              <a:tr h="1126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260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XQ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75171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60a0a"/>
                    </a:solidFill>
                  </a:tcPr>
                </a:tc>
              </a:tr>
              <a:tr h="1126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560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OC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b0a0a"/>
                    </a:solidFill>
                  </a:tcPr>
                </a:tc>
              </a:tr>
              <a:tr h="1144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620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OC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54d6c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b0808"/>
                    </a:solidFill>
                  </a:tcPr>
                </a:tc>
              </a:tr>
              <a:tr h="1126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140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OXY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5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1126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214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OXY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4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0202"/>
                    </a:solidFill>
                  </a:tcPr>
                </a:tc>
              </a:tr>
              <a:tr h="1126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629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OXY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9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  <a:tr h="1144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478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OXY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30b0b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  <a:tr h="1126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157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OXY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7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5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1126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156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OXY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37eb3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4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0101"/>
                    </a:solidFill>
                  </a:tcPr>
                </a:tc>
              </a:tr>
              <a:tr h="11412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156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OXY1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b71a1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2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1126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156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OXY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786bf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26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156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OXY1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17baf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304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629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OXY1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06087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0101"/>
                    </a:solidFill>
                  </a:tcPr>
                </a:tc>
              </a:tr>
              <a:tr h="11412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119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OXY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9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  <a:tr h="1126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330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OXY2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90a0a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.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  <a:tr h="1126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090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L2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80909"/>
                    </a:solidFill>
                  </a:tcPr>
                </a:tc>
              </a:tr>
              <a:tr h="1144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659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PX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75171"/>
                    </a:solidFill>
                  </a:tcPr>
                </a:tc>
              </a:tr>
              <a:tr h="1126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067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RX Z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20b0b"/>
                    </a:solidFill>
                  </a:tcPr>
                </a:tc>
              </a:tr>
              <a:tr h="1126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451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RX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56893"/>
                    </a:solidFill>
                  </a:tcPr>
                </a:tc>
              </a:tr>
              <a:tr h="1126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116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CP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54e6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20909"/>
                    </a:solidFill>
                  </a:tcPr>
                </a:tc>
              </a:tr>
              <a:tr h="1144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062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CP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e0909"/>
                    </a:solidFill>
                  </a:tcPr>
                </a:tc>
              </a:tr>
              <a:tr h="1126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138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138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44b69"/>
                    </a:solidFill>
                  </a:tcPr>
                </a:tc>
              </a:tr>
            </a:tbl>
          </a:graphicData>
        </a:graphic>
      </p:graphicFrame>
      <p:grpSp>
        <p:nvGrpSpPr>
          <p:cNvPr id="43" name="Gruppieren 1"/>
          <p:cNvGrpSpPr/>
          <p:nvPr/>
        </p:nvGrpSpPr>
        <p:grpSpPr>
          <a:xfrm>
            <a:off x="7021440" y="3803760"/>
            <a:ext cx="2022480" cy="394200"/>
            <a:chOff x="7021440" y="3803760"/>
            <a:chExt cx="2022480" cy="394200"/>
          </a:xfrm>
        </p:grpSpPr>
        <p:grpSp>
          <p:nvGrpSpPr>
            <p:cNvPr id="44" name="Gruppieren 5"/>
            <p:cNvGrpSpPr/>
            <p:nvPr/>
          </p:nvGrpSpPr>
          <p:grpSpPr>
            <a:xfrm>
              <a:off x="7105320" y="3803760"/>
              <a:ext cx="1938600" cy="215640"/>
              <a:chOff x="7105320" y="3803760"/>
              <a:chExt cx="1938600" cy="215640"/>
            </a:xfrm>
          </p:grpSpPr>
          <p:pic>
            <p:nvPicPr>
              <p:cNvPr id="45" name="Grafik 6" descr=""/>
              <p:cNvPicPr/>
              <p:nvPr/>
            </p:nvPicPr>
            <p:blipFill>
              <a:blip r:embed="rId1"/>
              <a:stretch/>
            </p:blipFill>
            <p:spPr>
              <a:xfrm>
                <a:off x="7105320" y="3835800"/>
                <a:ext cx="983520" cy="1663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6" name="Textfeld 2"/>
              <p:cNvSpPr/>
              <p:nvPr/>
            </p:nvSpPr>
            <p:spPr>
              <a:xfrm>
                <a:off x="8048880" y="3803760"/>
                <a:ext cx="995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og</a:t>
                </a: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fold change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47" name="Textfeld 2"/>
            <p:cNvSpPr/>
            <p:nvPr/>
          </p:nvSpPr>
          <p:spPr>
            <a:xfrm>
              <a:off x="7907040" y="3921480"/>
              <a:ext cx="246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feld 7"/>
            <p:cNvSpPr/>
            <p:nvPr/>
          </p:nvSpPr>
          <p:spPr>
            <a:xfrm>
              <a:off x="7021440" y="3909240"/>
              <a:ext cx="246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49" name="Gruppieren 11"/>
          <p:cNvGrpSpPr/>
          <p:nvPr/>
        </p:nvGrpSpPr>
        <p:grpSpPr>
          <a:xfrm>
            <a:off x="2554200" y="5421240"/>
            <a:ext cx="2021040" cy="394920"/>
            <a:chOff x="2554200" y="5421240"/>
            <a:chExt cx="2021040" cy="394920"/>
          </a:xfrm>
        </p:grpSpPr>
        <p:grpSp>
          <p:nvGrpSpPr>
            <p:cNvPr id="50" name="Gruppieren 5"/>
            <p:cNvGrpSpPr/>
            <p:nvPr/>
          </p:nvGrpSpPr>
          <p:grpSpPr>
            <a:xfrm>
              <a:off x="2637720" y="5421240"/>
              <a:ext cx="1937520" cy="215640"/>
              <a:chOff x="2637720" y="5421240"/>
              <a:chExt cx="1937520" cy="215640"/>
            </a:xfrm>
          </p:grpSpPr>
          <p:pic>
            <p:nvPicPr>
              <p:cNvPr id="51" name="Grafik 6" descr=""/>
              <p:cNvPicPr/>
              <p:nvPr/>
            </p:nvPicPr>
            <p:blipFill>
              <a:blip r:embed="rId2"/>
              <a:stretch/>
            </p:blipFill>
            <p:spPr>
              <a:xfrm>
                <a:off x="2637720" y="5453280"/>
                <a:ext cx="982800" cy="167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2" name="Textfeld 2"/>
              <p:cNvSpPr/>
              <p:nvPr/>
            </p:nvSpPr>
            <p:spPr>
              <a:xfrm>
                <a:off x="3580920" y="5421240"/>
                <a:ext cx="994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og</a:t>
                </a: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fold change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3" name="Textfeld 2"/>
            <p:cNvSpPr/>
            <p:nvPr/>
          </p:nvSpPr>
          <p:spPr>
            <a:xfrm>
              <a:off x="3439080" y="5539680"/>
              <a:ext cx="246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feld 7"/>
            <p:cNvSpPr/>
            <p:nvPr/>
          </p:nvSpPr>
          <p:spPr>
            <a:xfrm>
              <a:off x="2554200" y="5527080"/>
              <a:ext cx="246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5" name="Textfeld 1"/>
          <p:cNvSpPr/>
          <p:nvPr/>
        </p:nvSpPr>
        <p:spPr>
          <a:xfrm>
            <a:off x="190440" y="189000"/>
            <a:ext cx="1144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  <a:ea typeface="Arial"/>
              </a:rPr>
              <a:t>Fig. S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feld 18"/>
          <p:cNvSpPr/>
          <p:nvPr/>
        </p:nvSpPr>
        <p:spPr>
          <a:xfrm>
            <a:off x="2549520" y="523800"/>
            <a:ext cx="3290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  <a:ea typeface="Arial"/>
              </a:rPr>
              <a:t>genes involved in cellular redox statu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feld 19"/>
          <p:cNvSpPr/>
          <p:nvPr/>
        </p:nvSpPr>
        <p:spPr>
          <a:xfrm>
            <a:off x="7077240" y="519120"/>
            <a:ext cx="3290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  <a:ea typeface="Arial"/>
              </a:rPr>
              <a:t>genes involved in stomatal function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3-04T16:17:22Z</dcterms:created>
  <dc:creator>Hossein</dc:creator>
  <dc:description/>
  <dc:language>en-US</dc:language>
  <cp:lastModifiedBy>Hossein</cp:lastModifiedBy>
  <dcterms:modified xsi:type="dcterms:W3CDTF">2020-03-20T15:34:43Z</dcterms:modified>
  <cp:revision>14</cp:revision>
  <dc:subject/>
  <dc:title>PowerPoint-Präsentation</dc:title>
</cp:coreProperties>
</file>